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8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192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059"/>
    <p:restoredTop sz="94567" autoAdjust="0"/>
  </p:normalViewPr>
  <p:slideViewPr>
    <p:cSldViewPr snapToGrid="0" snapToObjects="1">
      <p:cViewPr>
        <p:scale>
          <a:sx n="139" d="100"/>
          <a:sy n="139" d="100"/>
        </p:scale>
        <p:origin x="1128" y="-3984"/>
      </p:cViewPr>
      <p:guideLst>
        <p:guide orient="horz" pos="2880"/>
        <p:guide pos="192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naganorikamiyama:Documents:Documents:&#24863;&#26579;&#20104;&#38450;%20&#23455;&#39443;&#12487;&#12540;&#12479;:EAE:20200731%20normal%20EAE%2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899952615243281"/>
          <c:y val="0.048447489315976"/>
          <c:w val="0.888607830271216"/>
          <c:h val="0.756798993875765"/>
        </c:manualLayout>
      </c:layout>
      <c:lineChart>
        <c:grouping val="standard"/>
        <c:varyColors val="0"/>
        <c:ser>
          <c:idx val="0"/>
          <c:order val="0"/>
          <c:tx>
            <c:strRef>
              <c:f>Sheet1!$A$16</c:f>
              <c:strCache>
                <c:ptCount val="1"/>
                <c:pt idx="0">
                  <c:v>NC </c:v>
                </c:pt>
              </c:strCache>
            </c:strRef>
          </c:tx>
          <c:spPr>
            <a:ln w="19050"/>
          </c:spPr>
          <c:cat>
            <c:strRef>
              <c:f>Sheet1!$B$1:$W$1</c:f>
              <c:strCache>
                <c:ptCount val="22"/>
                <c:pt idx="0">
                  <c:v>day0</c:v>
                </c:pt>
                <c:pt idx="1">
                  <c:v>day1</c:v>
                </c:pt>
                <c:pt idx="2">
                  <c:v>day2</c:v>
                </c:pt>
                <c:pt idx="3">
                  <c:v>day3</c:v>
                </c:pt>
                <c:pt idx="4">
                  <c:v>day4</c:v>
                </c:pt>
                <c:pt idx="5">
                  <c:v>day5</c:v>
                </c:pt>
                <c:pt idx="6">
                  <c:v>day6</c:v>
                </c:pt>
                <c:pt idx="7">
                  <c:v>day7</c:v>
                </c:pt>
                <c:pt idx="8">
                  <c:v>day8</c:v>
                </c:pt>
                <c:pt idx="9">
                  <c:v>day9</c:v>
                </c:pt>
                <c:pt idx="10">
                  <c:v>day10</c:v>
                </c:pt>
                <c:pt idx="11">
                  <c:v>day11</c:v>
                </c:pt>
                <c:pt idx="12">
                  <c:v>day12</c:v>
                </c:pt>
                <c:pt idx="13">
                  <c:v>day13</c:v>
                </c:pt>
                <c:pt idx="14">
                  <c:v>day14</c:v>
                </c:pt>
                <c:pt idx="15">
                  <c:v>day15</c:v>
                </c:pt>
                <c:pt idx="16">
                  <c:v>day16</c:v>
                </c:pt>
                <c:pt idx="17">
                  <c:v>day17</c:v>
                </c:pt>
                <c:pt idx="18">
                  <c:v>day18</c:v>
                </c:pt>
                <c:pt idx="19">
                  <c:v>day19</c:v>
                </c:pt>
                <c:pt idx="20">
                  <c:v>day20</c:v>
                </c:pt>
                <c:pt idx="21">
                  <c:v>day21</c:v>
                </c:pt>
              </c:strCache>
            </c:strRef>
          </c:cat>
          <c:val>
            <c:numRef>
              <c:f>Sheet1!$B$16:$W$16</c:f>
              <c:numCache>
                <c:formatCode>General</c:formatCode>
                <c:ptCount val="22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0.0</c:v>
                </c:pt>
                <c:pt idx="15">
                  <c:v>0.0</c:v>
                </c:pt>
                <c:pt idx="16">
                  <c:v>0.0</c:v>
                </c:pt>
                <c:pt idx="17">
                  <c:v>0.0</c:v>
                </c:pt>
                <c:pt idx="18">
                  <c:v>0.0</c:v>
                </c:pt>
                <c:pt idx="19">
                  <c:v>0.0</c:v>
                </c:pt>
                <c:pt idx="20">
                  <c:v>0.0</c:v>
                </c:pt>
                <c:pt idx="21">
                  <c:v>0.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DF40-DD46-97F7-1E791D4763D6}"/>
            </c:ext>
          </c:extLst>
        </c:ser>
        <c:ser>
          <c:idx val="1"/>
          <c:order val="1"/>
          <c:tx>
            <c:strRef>
              <c:f>Sheet1!$A$17</c:f>
              <c:strCache>
                <c:ptCount val="1"/>
                <c:pt idx="0">
                  <c:v>ZIKV EAE </c:v>
                </c:pt>
              </c:strCache>
            </c:strRef>
          </c:tx>
          <c:spPr>
            <a:ln w="15875">
              <a:solidFill>
                <a:srgbClr val="FF0000"/>
              </a:solidFill>
            </a:ln>
            <a:effectLst/>
          </c:spPr>
          <c:marker>
            <c:symbol val="circle"/>
            <c:size val="4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c:spPr>
          </c:marker>
          <c:cat>
            <c:strRef>
              <c:f>Sheet1!$B$1:$W$1</c:f>
              <c:strCache>
                <c:ptCount val="22"/>
                <c:pt idx="0">
                  <c:v>day0</c:v>
                </c:pt>
                <c:pt idx="1">
                  <c:v>day1</c:v>
                </c:pt>
                <c:pt idx="2">
                  <c:v>day2</c:v>
                </c:pt>
                <c:pt idx="3">
                  <c:v>day3</c:v>
                </c:pt>
                <c:pt idx="4">
                  <c:v>day4</c:v>
                </c:pt>
                <c:pt idx="5">
                  <c:v>day5</c:v>
                </c:pt>
                <c:pt idx="6">
                  <c:v>day6</c:v>
                </c:pt>
                <c:pt idx="7">
                  <c:v>day7</c:v>
                </c:pt>
                <c:pt idx="8">
                  <c:v>day8</c:v>
                </c:pt>
                <c:pt idx="9">
                  <c:v>day9</c:v>
                </c:pt>
                <c:pt idx="10">
                  <c:v>day10</c:v>
                </c:pt>
                <c:pt idx="11">
                  <c:v>day11</c:v>
                </c:pt>
                <c:pt idx="12">
                  <c:v>day12</c:v>
                </c:pt>
                <c:pt idx="13">
                  <c:v>day13</c:v>
                </c:pt>
                <c:pt idx="14">
                  <c:v>day14</c:v>
                </c:pt>
                <c:pt idx="15">
                  <c:v>day15</c:v>
                </c:pt>
                <c:pt idx="16">
                  <c:v>day16</c:v>
                </c:pt>
                <c:pt idx="17">
                  <c:v>day17</c:v>
                </c:pt>
                <c:pt idx="18">
                  <c:v>day18</c:v>
                </c:pt>
                <c:pt idx="19">
                  <c:v>day19</c:v>
                </c:pt>
                <c:pt idx="20">
                  <c:v>day20</c:v>
                </c:pt>
                <c:pt idx="21">
                  <c:v>day21</c:v>
                </c:pt>
              </c:strCache>
            </c:strRef>
          </c:cat>
          <c:val>
            <c:numRef>
              <c:f>Sheet1!$B$17:$W$17</c:f>
              <c:numCache>
                <c:formatCode>General</c:formatCode>
                <c:ptCount val="22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0.0</c:v>
                </c:pt>
                <c:pt idx="15">
                  <c:v>0.0</c:v>
                </c:pt>
                <c:pt idx="16">
                  <c:v>0.0</c:v>
                </c:pt>
                <c:pt idx="17">
                  <c:v>0.0</c:v>
                </c:pt>
                <c:pt idx="18">
                  <c:v>0.0</c:v>
                </c:pt>
                <c:pt idx="19">
                  <c:v>0.0</c:v>
                </c:pt>
                <c:pt idx="20">
                  <c:v>0.0</c:v>
                </c:pt>
                <c:pt idx="21">
                  <c:v>0.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DF40-DD46-97F7-1E791D4763D6}"/>
            </c:ext>
          </c:extLst>
        </c:ser>
        <c:ser>
          <c:idx val="2"/>
          <c:order val="2"/>
          <c:tx>
            <c:strRef>
              <c:f>Sheet1!$A$18</c:f>
              <c:strCache>
                <c:ptCount val="1"/>
                <c:pt idx="0">
                  <c:v>MOG EAE </c:v>
                </c:pt>
              </c:strCache>
            </c:strRef>
          </c:tx>
          <c:spPr>
            <a:ln w="15875">
              <a:solidFill>
                <a:schemeClr val="tx1"/>
              </a:solidFill>
            </a:ln>
            <a:effectLst/>
          </c:spPr>
          <c:marker>
            <c:symbol val="triangle"/>
            <c:size val="4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1!$B$21:$W$21</c:f>
                <c:numCache>
                  <c:formatCode>General</c:formatCode>
                  <c:ptCount val="22"/>
                  <c:pt idx="0">
                    <c:v>0.0</c:v>
                  </c:pt>
                  <c:pt idx="1">
                    <c:v>0.0</c:v>
                  </c:pt>
                  <c:pt idx="2">
                    <c:v>0.0</c:v>
                  </c:pt>
                  <c:pt idx="3">
                    <c:v>0.0</c:v>
                  </c:pt>
                  <c:pt idx="4">
                    <c:v>0.0</c:v>
                  </c:pt>
                  <c:pt idx="5">
                    <c:v>0.0</c:v>
                  </c:pt>
                  <c:pt idx="6">
                    <c:v>0.0</c:v>
                  </c:pt>
                  <c:pt idx="7">
                    <c:v>0.0</c:v>
                  </c:pt>
                  <c:pt idx="8">
                    <c:v>0.0</c:v>
                  </c:pt>
                  <c:pt idx="9">
                    <c:v>0.0</c:v>
                  </c:pt>
                  <c:pt idx="10">
                    <c:v>0.0</c:v>
                  </c:pt>
                  <c:pt idx="11">
                    <c:v>0.0</c:v>
                  </c:pt>
                  <c:pt idx="12">
                    <c:v>0.0</c:v>
                  </c:pt>
                  <c:pt idx="13">
                    <c:v>0.577350269189626</c:v>
                  </c:pt>
                  <c:pt idx="14">
                    <c:v>0.577350269189626</c:v>
                  </c:pt>
                  <c:pt idx="15">
                    <c:v>0.957427107756338</c:v>
                  </c:pt>
                  <c:pt idx="16">
                    <c:v>0.577350269189626</c:v>
                  </c:pt>
                  <c:pt idx="17">
                    <c:v>0.577350269189626</c:v>
                  </c:pt>
                  <c:pt idx="18">
                    <c:v>0.957427107756338</c:v>
                  </c:pt>
                  <c:pt idx="19">
                    <c:v>0.816496580927726</c:v>
                  </c:pt>
                  <c:pt idx="20">
                    <c:v>0.5</c:v>
                  </c:pt>
                  <c:pt idx="21">
                    <c:v>0.57735026918962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ln w="0">
                <a:solidFill>
                  <a:schemeClr val="tx1">
                    <a:lumMod val="75000"/>
                    <a:lumOff val="25000"/>
                  </a:schemeClr>
                </a:solidFill>
              </a:ln>
            </c:spPr>
          </c:errBars>
          <c:cat>
            <c:strRef>
              <c:f>Sheet1!$B$1:$W$1</c:f>
              <c:strCache>
                <c:ptCount val="22"/>
                <c:pt idx="0">
                  <c:v>day0</c:v>
                </c:pt>
                <c:pt idx="1">
                  <c:v>day1</c:v>
                </c:pt>
                <c:pt idx="2">
                  <c:v>day2</c:v>
                </c:pt>
                <c:pt idx="3">
                  <c:v>day3</c:v>
                </c:pt>
                <c:pt idx="4">
                  <c:v>day4</c:v>
                </c:pt>
                <c:pt idx="5">
                  <c:v>day5</c:v>
                </c:pt>
                <c:pt idx="6">
                  <c:v>day6</c:v>
                </c:pt>
                <c:pt idx="7">
                  <c:v>day7</c:v>
                </c:pt>
                <c:pt idx="8">
                  <c:v>day8</c:v>
                </c:pt>
                <c:pt idx="9">
                  <c:v>day9</c:v>
                </c:pt>
                <c:pt idx="10">
                  <c:v>day10</c:v>
                </c:pt>
                <c:pt idx="11">
                  <c:v>day11</c:v>
                </c:pt>
                <c:pt idx="12">
                  <c:v>day12</c:v>
                </c:pt>
                <c:pt idx="13">
                  <c:v>day13</c:v>
                </c:pt>
                <c:pt idx="14">
                  <c:v>day14</c:v>
                </c:pt>
                <c:pt idx="15">
                  <c:v>day15</c:v>
                </c:pt>
                <c:pt idx="16">
                  <c:v>day16</c:v>
                </c:pt>
                <c:pt idx="17">
                  <c:v>day17</c:v>
                </c:pt>
                <c:pt idx="18">
                  <c:v>day18</c:v>
                </c:pt>
                <c:pt idx="19">
                  <c:v>day19</c:v>
                </c:pt>
                <c:pt idx="20">
                  <c:v>day20</c:v>
                </c:pt>
                <c:pt idx="21">
                  <c:v>day21</c:v>
                </c:pt>
              </c:strCache>
            </c:strRef>
          </c:cat>
          <c:val>
            <c:numRef>
              <c:f>Sheet1!$B$18:$W$18</c:f>
              <c:numCache>
                <c:formatCode>General</c:formatCode>
                <c:ptCount val="22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5</c:v>
                </c:pt>
                <c:pt idx="14">
                  <c:v>1.5</c:v>
                </c:pt>
                <c:pt idx="15">
                  <c:v>2.25</c:v>
                </c:pt>
                <c:pt idx="16">
                  <c:v>3.5</c:v>
                </c:pt>
                <c:pt idx="17">
                  <c:v>3.5</c:v>
                </c:pt>
                <c:pt idx="18">
                  <c:v>3.25</c:v>
                </c:pt>
                <c:pt idx="19">
                  <c:v>3.0</c:v>
                </c:pt>
                <c:pt idx="20">
                  <c:v>2.75</c:v>
                </c:pt>
                <c:pt idx="21">
                  <c:v>2.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DF40-DD46-97F7-1E791D4763D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066944080"/>
        <c:axId val="2136133536"/>
      </c:lineChart>
      <c:catAx>
        <c:axId val="-20669440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ja-JP"/>
          </a:p>
        </c:txPr>
        <c:crossAx val="2136133536"/>
        <c:crosses val="autoZero"/>
        <c:auto val="1"/>
        <c:lblAlgn val="ctr"/>
        <c:lblOffset val="100"/>
        <c:tickLblSkip val="2"/>
        <c:noMultiLvlLbl val="0"/>
      </c:catAx>
      <c:valAx>
        <c:axId val="21361335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ja-JP"/>
          </a:p>
        </c:txPr>
        <c:crossAx val="-2066944080"/>
        <c:crosses val="autoZero"/>
        <c:crossBetween val="between"/>
      </c:valAx>
      <c:spPr>
        <a:ln w="19050"/>
      </c:spPr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1B4E21-F6CD-9F42-BC12-6716A2311E9A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999E1D-F594-7D47-B0D0-FBEEAB6878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28786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999E1D-F594-7D47-B0D0-FBEEAB6878AB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90303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8732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84250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08964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8162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6975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44987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4597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4900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2179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10402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48870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608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4" Type="http://schemas.openxmlformats.org/officeDocument/2006/relationships/chart" Target="../charts/chart1.xml"/><Relationship Id="rId5" Type="http://schemas.openxmlformats.org/officeDocument/2006/relationships/image" Target="../media/image2.emf"/><Relationship Id="rId6" Type="http://schemas.openxmlformats.org/officeDocument/2006/relationships/image" Target="../media/image3.emf"/><Relationship Id="rId7" Type="http://schemas.openxmlformats.org/officeDocument/2006/relationships/image" Target="../media/image4.emf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45"/>
          <p:cNvSpPr txBox="1">
            <a:spLocks noChangeArrowheads="1"/>
          </p:cNvSpPr>
          <p:nvPr/>
        </p:nvSpPr>
        <p:spPr bwMode="auto">
          <a:xfrm>
            <a:off x="1126277" y="32098"/>
            <a:ext cx="5820186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1800" dirty="0">
                <a:latin typeface="Helvetica"/>
                <a:cs typeface="Helvetica"/>
              </a:rPr>
              <a:t> </a:t>
            </a:r>
            <a:r>
              <a:rPr lang="en-US" altLang="ja-JP" dirty="0">
                <a:latin typeface="Helvetica"/>
                <a:cs typeface="Helvetica"/>
              </a:rPr>
              <a:t>Supplementary </a:t>
            </a:r>
            <a:r>
              <a:rPr lang="en-US" altLang="ja-JP" dirty="0" smtClean="0">
                <a:latin typeface="Helvetica"/>
                <a:cs typeface="Helvetica"/>
              </a:rPr>
              <a:t>Fig.S12_Kamiyama </a:t>
            </a:r>
            <a:r>
              <a:rPr lang="en-US" altLang="ja-JP" dirty="0">
                <a:latin typeface="Helvetica"/>
                <a:cs typeface="Helvetica"/>
              </a:rPr>
              <a:t>et al.</a:t>
            </a:r>
            <a:endParaRPr lang="ja-JP" altLang="en-US" dirty="0">
              <a:latin typeface="Helvetica"/>
              <a:cs typeface="Helvetica"/>
            </a:endParaRPr>
          </a:p>
        </p:txBody>
      </p:sp>
      <p:pic>
        <p:nvPicPr>
          <p:cNvPr id="15" name="図 14"/>
          <p:cNvPicPr>
            <a:picLocks noChangeAspect="1"/>
          </p:cNvPicPr>
          <p:nvPr/>
        </p:nvPicPr>
        <p:blipFill rotWithShape="1">
          <a:blip r:embed="rId3"/>
          <a:srcRect l="6040" r="25425" b="7025"/>
          <a:stretch/>
        </p:blipFill>
        <p:spPr>
          <a:xfrm>
            <a:off x="4025873" y="1696233"/>
            <a:ext cx="1712332" cy="1231862"/>
          </a:xfrm>
          <a:prstGeom prst="rect">
            <a:avLst/>
          </a:prstGeom>
        </p:spPr>
      </p:pic>
      <p:sp>
        <p:nvSpPr>
          <p:cNvPr id="16" name="テキスト ボックス 15">
            <a:extLst>
              <a:ext uri="{FF2B5EF4-FFF2-40B4-BE49-F238E27FC236}">
                <a16:creationId xmlns="" xmlns:a16="http://schemas.microsoft.com/office/drawing/2014/main" id="{881C648C-4D20-384D-AC37-A3723D2ABD15}"/>
              </a:ext>
            </a:extLst>
          </p:cNvPr>
          <p:cNvSpPr txBox="1"/>
          <p:nvPr/>
        </p:nvSpPr>
        <p:spPr>
          <a:xfrm>
            <a:off x="4190619" y="2961624"/>
            <a:ext cx="13322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Helvetica"/>
                <a:cs typeface="Helvetica"/>
              </a:rPr>
              <a:t>ZIKV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="" xmlns:a16="http://schemas.microsoft.com/office/drawing/2014/main" id="{881C648C-4D20-384D-AC37-A3723D2ABD15}"/>
              </a:ext>
            </a:extLst>
          </p:cNvPr>
          <p:cNvSpPr txBox="1"/>
          <p:nvPr/>
        </p:nvSpPr>
        <p:spPr>
          <a:xfrm>
            <a:off x="4957268" y="2956246"/>
            <a:ext cx="8149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Helvetica"/>
                <a:cs typeface="Helvetica"/>
              </a:rPr>
              <a:t>MOG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="" xmlns:a16="http://schemas.microsoft.com/office/drawing/2014/main" id="{DE107980-2943-BD4E-936A-8EB9F837DD56}"/>
              </a:ext>
            </a:extLst>
          </p:cNvPr>
          <p:cNvSpPr txBox="1"/>
          <p:nvPr/>
        </p:nvSpPr>
        <p:spPr>
          <a:xfrm>
            <a:off x="4070658" y="2960382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TRL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="" xmlns:a16="http://schemas.microsoft.com/office/drawing/2014/main" id="{F07E629E-B719-D946-9289-C4F6303E9A11}"/>
              </a:ext>
            </a:extLst>
          </p:cNvPr>
          <p:cNvSpPr txBox="1"/>
          <p:nvPr/>
        </p:nvSpPr>
        <p:spPr>
          <a:xfrm>
            <a:off x="3797154" y="2727249"/>
            <a:ext cx="262627" cy="2417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cxnSp>
        <p:nvCxnSpPr>
          <p:cNvPr id="23" name="直線コネクタ 22">
            <a:extLst>
              <a:ext uri="{FF2B5EF4-FFF2-40B4-BE49-F238E27FC236}">
                <a16:creationId xmlns="" xmlns:a16="http://schemas.microsoft.com/office/drawing/2014/main" id="{6DC12DAF-D84D-A149-BACF-21771DAE9F2A}"/>
              </a:ext>
            </a:extLst>
          </p:cNvPr>
          <p:cNvCxnSpPr>
            <a:cxnSpLocks/>
          </p:cNvCxnSpPr>
          <p:nvPr/>
        </p:nvCxnSpPr>
        <p:spPr>
          <a:xfrm>
            <a:off x="4353201" y="1830786"/>
            <a:ext cx="1004327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テキスト ボックス 23">
            <a:extLst>
              <a:ext uri="{FF2B5EF4-FFF2-40B4-BE49-F238E27FC236}">
                <a16:creationId xmlns="" xmlns:a16="http://schemas.microsoft.com/office/drawing/2014/main" id="{881C648C-4D20-384D-AC37-A3723D2ABD15}"/>
              </a:ext>
            </a:extLst>
          </p:cNvPr>
          <p:cNvSpPr txBox="1"/>
          <p:nvPr/>
        </p:nvSpPr>
        <p:spPr>
          <a:xfrm>
            <a:off x="4753271" y="1650099"/>
            <a:ext cx="4594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*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="" xmlns:a16="http://schemas.microsoft.com/office/drawing/2014/main" id="{F07E629E-B719-D946-9289-C4F6303E9A11}"/>
              </a:ext>
            </a:extLst>
          </p:cNvPr>
          <p:cNvSpPr txBox="1"/>
          <p:nvPr/>
        </p:nvSpPr>
        <p:spPr>
          <a:xfrm>
            <a:off x="3796664" y="2450250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="" xmlns:a16="http://schemas.microsoft.com/office/drawing/2014/main" id="{F07E629E-B719-D946-9289-C4F6303E9A11}"/>
              </a:ext>
            </a:extLst>
          </p:cNvPr>
          <p:cNvSpPr txBox="1"/>
          <p:nvPr/>
        </p:nvSpPr>
        <p:spPr>
          <a:xfrm>
            <a:off x="3796664" y="2166116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="" xmlns:a16="http://schemas.microsoft.com/office/drawing/2014/main" id="{F07E629E-B719-D946-9289-C4F6303E9A11}"/>
              </a:ext>
            </a:extLst>
          </p:cNvPr>
          <p:cNvSpPr txBox="1"/>
          <p:nvPr/>
        </p:nvSpPr>
        <p:spPr>
          <a:xfrm>
            <a:off x="3797154" y="1889117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3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="" xmlns:a16="http://schemas.microsoft.com/office/drawing/2014/main" id="{F07E629E-B719-D946-9289-C4F6303E9A11}"/>
              </a:ext>
            </a:extLst>
          </p:cNvPr>
          <p:cNvSpPr txBox="1"/>
          <p:nvPr/>
        </p:nvSpPr>
        <p:spPr>
          <a:xfrm>
            <a:off x="3796664" y="1619984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cxnSp>
        <p:nvCxnSpPr>
          <p:cNvPr id="31" name="直線コネクタ 30">
            <a:extLst>
              <a:ext uri="{FF2B5EF4-FFF2-40B4-BE49-F238E27FC236}">
                <a16:creationId xmlns="" xmlns:a16="http://schemas.microsoft.com/office/drawing/2014/main" id="{6DC12DAF-D84D-A149-BACF-21771DAE9F2A}"/>
              </a:ext>
            </a:extLst>
          </p:cNvPr>
          <p:cNvCxnSpPr>
            <a:cxnSpLocks/>
          </p:cNvCxnSpPr>
          <p:nvPr/>
        </p:nvCxnSpPr>
        <p:spPr>
          <a:xfrm>
            <a:off x="4353201" y="2538770"/>
            <a:ext cx="537047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" name="テキスト ボックス 31">
            <a:extLst>
              <a:ext uri="{FF2B5EF4-FFF2-40B4-BE49-F238E27FC236}">
                <a16:creationId xmlns="" xmlns:a16="http://schemas.microsoft.com/office/drawing/2014/main" id="{881C648C-4D20-384D-AC37-A3723D2ABD15}"/>
              </a:ext>
            </a:extLst>
          </p:cNvPr>
          <p:cNvSpPr txBox="1"/>
          <p:nvPr/>
        </p:nvSpPr>
        <p:spPr>
          <a:xfrm>
            <a:off x="4273481" y="2312164"/>
            <a:ext cx="6524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Helvetica"/>
                <a:cs typeface="Helvetica"/>
              </a:rPr>
              <a:t>N.S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 rot="16200000">
            <a:off x="3150452" y="2193963"/>
            <a:ext cx="107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/>
                <a:cs typeface="Helvetica"/>
              </a:rPr>
              <a:t>O.D. 450 nm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4353201" y="1052766"/>
            <a:ext cx="9968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α</a:t>
            </a:r>
            <a:r>
              <a:rPr kumimoji="1" lang="en-US" altLang="ja-JP" sz="1200" b="1" dirty="0">
                <a:latin typeface="Helvetica"/>
                <a:cs typeface="Helvetica"/>
              </a:rPr>
              <a:t>-MOG IgG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graphicFrame>
        <p:nvGraphicFramePr>
          <p:cNvPr id="37" name="グラフ 3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03803383"/>
              </p:ext>
            </p:extLst>
          </p:nvPr>
        </p:nvGraphicFramePr>
        <p:xfrm>
          <a:off x="474101" y="1156697"/>
          <a:ext cx="2808943" cy="21523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0" name="テキスト ボックス 64">
            <a:extLst>
              <a:ext uri="{FF2B5EF4-FFF2-40B4-BE49-F238E27FC236}">
                <a16:creationId xmlns="" xmlns:a16="http://schemas.microsoft.com/office/drawing/2014/main" id="{25475C08-8620-2A47-820C-6823C49591D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9525" y="615539"/>
            <a:ext cx="38985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dirty="0">
                <a:latin typeface="Helvetica" charset="0"/>
                <a:cs typeface="Helvetica" charset="0"/>
              </a:rPr>
              <a:t>A</a:t>
            </a:r>
            <a:endParaRPr lang="ja-JP" altLang="en-US" dirty="0">
              <a:latin typeface="Helvetica" charset="0"/>
              <a:cs typeface="Helvetica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="" xmlns:a16="http://schemas.microsoft.com/office/drawing/2014/main" id="{2A3321E8-A6B8-CC46-829B-47981A12AF76}"/>
              </a:ext>
            </a:extLst>
          </p:cNvPr>
          <p:cNvSpPr txBox="1"/>
          <p:nvPr/>
        </p:nvSpPr>
        <p:spPr>
          <a:xfrm>
            <a:off x="957635" y="1674532"/>
            <a:ext cx="89437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ZIKV</a:t>
            </a:r>
            <a:r>
              <a:rPr lang="ja-JP" altLang="en-US" sz="12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EAE</a:t>
            </a:r>
            <a:r>
              <a:rPr lang="ja-JP" altLang="en-US" sz="1200" b="1" dirty="0">
                <a:latin typeface="Helvetica"/>
                <a:ea typeface="Helvetica" charset="0"/>
                <a:cs typeface="Helvetica"/>
              </a:rPr>
              <a:t> </a:t>
            </a:r>
          </a:p>
        </p:txBody>
      </p:sp>
      <p:sp>
        <p:nvSpPr>
          <p:cNvPr id="72" name="テキスト ボックス 71">
            <a:extLst>
              <a:ext uri="{FF2B5EF4-FFF2-40B4-BE49-F238E27FC236}">
                <a16:creationId xmlns="" xmlns:a16="http://schemas.microsoft.com/office/drawing/2014/main" id="{2A3321E8-A6B8-CC46-829B-47981A12AF76}"/>
              </a:ext>
            </a:extLst>
          </p:cNvPr>
          <p:cNvSpPr txBox="1"/>
          <p:nvPr/>
        </p:nvSpPr>
        <p:spPr>
          <a:xfrm>
            <a:off x="957635" y="1957074"/>
            <a:ext cx="915635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MOG</a:t>
            </a:r>
            <a:r>
              <a:rPr lang="ja-JP" altLang="en-US" sz="12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73" name="正方形/長方形 72"/>
          <p:cNvSpPr/>
          <p:nvPr/>
        </p:nvSpPr>
        <p:spPr>
          <a:xfrm>
            <a:off x="555827" y="2963155"/>
            <a:ext cx="2585759" cy="354587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 b="1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="" xmlns:a16="http://schemas.microsoft.com/office/drawing/2014/main" id="{6C9B4AC2-8BC4-5044-A4F7-D11B34E9EEAF}"/>
              </a:ext>
            </a:extLst>
          </p:cNvPr>
          <p:cNvSpPr txBox="1"/>
          <p:nvPr/>
        </p:nvSpPr>
        <p:spPr>
          <a:xfrm>
            <a:off x="642667" y="2928095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="" xmlns:a16="http://schemas.microsoft.com/office/drawing/2014/main" id="{79394661-8AAD-894B-B321-DF2F09BB1A34}"/>
              </a:ext>
            </a:extLst>
          </p:cNvPr>
          <p:cNvSpPr txBox="1"/>
          <p:nvPr/>
        </p:nvSpPr>
        <p:spPr>
          <a:xfrm>
            <a:off x="868120" y="2928095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="" xmlns:a16="http://schemas.microsoft.com/office/drawing/2014/main" id="{64CEF990-A5BD-1841-BC92-8E9FF5558D96}"/>
              </a:ext>
            </a:extLst>
          </p:cNvPr>
          <p:cNvSpPr txBox="1"/>
          <p:nvPr/>
        </p:nvSpPr>
        <p:spPr>
          <a:xfrm>
            <a:off x="1076001" y="2928095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="" xmlns:a16="http://schemas.microsoft.com/office/drawing/2014/main" id="{B6F9BB82-7EF2-C24B-863C-A6CC60B52B68}"/>
              </a:ext>
            </a:extLst>
          </p:cNvPr>
          <p:cNvSpPr txBox="1"/>
          <p:nvPr/>
        </p:nvSpPr>
        <p:spPr>
          <a:xfrm>
            <a:off x="1301455" y="2928095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6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="" xmlns:a16="http://schemas.microsoft.com/office/drawing/2014/main" id="{708A8313-4EBE-A84D-8CE5-144CF9CD6118}"/>
              </a:ext>
            </a:extLst>
          </p:cNvPr>
          <p:cNvSpPr txBox="1"/>
          <p:nvPr/>
        </p:nvSpPr>
        <p:spPr>
          <a:xfrm>
            <a:off x="1521050" y="2928095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8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="" xmlns:a16="http://schemas.microsoft.com/office/drawing/2014/main" id="{552FD492-0E6C-2447-9746-C05FAA652532}"/>
              </a:ext>
            </a:extLst>
          </p:cNvPr>
          <p:cNvSpPr txBox="1"/>
          <p:nvPr/>
        </p:nvSpPr>
        <p:spPr>
          <a:xfrm>
            <a:off x="1705500" y="2928095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="" xmlns:a16="http://schemas.microsoft.com/office/drawing/2014/main" id="{EE14A61E-8929-9048-B5CD-28FB87B52101}"/>
              </a:ext>
            </a:extLst>
          </p:cNvPr>
          <p:cNvSpPr txBox="1"/>
          <p:nvPr/>
        </p:nvSpPr>
        <p:spPr>
          <a:xfrm>
            <a:off x="1923878" y="2928095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="" xmlns:a16="http://schemas.microsoft.com/office/drawing/2014/main" id="{AC43DEE9-DE8D-1F42-9452-B6EC573F5AEF}"/>
              </a:ext>
            </a:extLst>
          </p:cNvPr>
          <p:cNvSpPr txBox="1"/>
          <p:nvPr/>
        </p:nvSpPr>
        <p:spPr>
          <a:xfrm>
            <a:off x="2148108" y="2928095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="" xmlns:a16="http://schemas.microsoft.com/office/drawing/2014/main" id="{4A6B2414-AE33-0B4D-A30D-13F9DAF35054}"/>
              </a:ext>
            </a:extLst>
          </p:cNvPr>
          <p:cNvSpPr txBox="1"/>
          <p:nvPr/>
        </p:nvSpPr>
        <p:spPr>
          <a:xfrm>
            <a:off x="2366483" y="2928095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6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="" xmlns:a16="http://schemas.microsoft.com/office/drawing/2014/main" id="{DA6CE7E4-2C9E-4C44-9865-4688AC918023}"/>
              </a:ext>
            </a:extLst>
          </p:cNvPr>
          <p:cNvSpPr txBox="1"/>
          <p:nvPr/>
        </p:nvSpPr>
        <p:spPr>
          <a:xfrm>
            <a:off x="2579001" y="2928095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8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="" xmlns:a16="http://schemas.microsoft.com/office/drawing/2014/main" id="{C0F527A3-9827-C44F-AD18-EDB55DE1211A}"/>
              </a:ext>
            </a:extLst>
          </p:cNvPr>
          <p:cNvSpPr txBox="1"/>
          <p:nvPr/>
        </p:nvSpPr>
        <p:spPr>
          <a:xfrm>
            <a:off x="2808236" y="2928095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93" name="テキスト ボックス 92"/>
          <p:cNvSpPr txBox="1"/>
          <p:nvPr/>
        </p:nvSpPr>
        <p:spPr>
          <a:xfrm>
            <a:off x="971515" y="3199826"/>
            <a:ext cx="19633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Days after immunization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94" name="正方形/長方形 93"/>
          <p:cNvSpPr/>
          <p:nvPr/>
        </p:nvSpPr>
        <p:spPr>
          <a:xfrm rot="5400000">
            <a:off x="-497255" y="1987185"/>
            <a:ext cx="1987023" cy="354587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 b="1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95" name="テキスト ボックス 94"/>
          <p:cNvSpPr txBox="1"/>
          <p:nvPr/>
        </p:nvSpPr>
        <p:spPr>
          <a:xfrm rot="16200000">
            <a:off x="-277706" y="1876661"/>
            <a:ext cx="12024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linical Score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="" xmlns:a16="http://schemas.microsoft.com/office/drawing/2014/main" id="{F07E629E-B719-D946-9289-C4F6303E9A11}"/>
              </a:ext>
            </a:extLst>
          </p:cNvPr>
          <p:cNvSpPr txBox="1"/>
          <p:nvPr/>
        </p:nvSpPr>
        <p:spPr>
          <a:xfrm>
            <a:off x="463335" y="2714076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="" xmlns:a16="http://schemas.microsoft.com/office/drawing/2014/main" id="{EF05A6EE-448A-1840-A05D-D94077708515}"/>
              </a:ext>
            </a:extLst>
          </p:cNvPr>
          <p:cNvSpPr txBox="1"/>
          <p:nvPr/>
        </p:nvSpPr>
        <p:spPr>
          <a:xfrm>
            <a:off x="463335" y="2394606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="" xmlns:a16="http://schemas.microsoft.com/office/drawing/2014/main" id="{AC0C3899-0921-4F4C-93E7-1B96239CE567}"/>
              </a:ext>
            </a:extLst>
          </p:cNvPr>
          <p:cNvSpPr txBox="1"/>
          <p:nvPr/>
        </p:nvSpPr>
        <p:spPr>
          <a:xfrm>
            <a:off x="463335" y="2067120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="" xmlns:a16="http://schemas.microsoft.com/office/drawing/2014/main" id="{0E4B548D-540A-954F-AAC0-F6D6CA09E4FA}"/>
              </a:ext>
            </a:extLst>
          </p:cNvPr>
          <p:cNvSpPr txBox="1"/>
          <p:nvPr/>
        </p:nvSpPr>
        <p:spPr>
          <a:xfrm>
            <a:off x="463335" y="1752764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3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="" xmlns:a16="http://schemas.microsoft.com/office/drawing/2014/main" id="{F4C64E0E-D4C1-7F4F-9D02-BDC788DDE822}"/>
              </a:ext>
            </a:extLst>
          </p:cNvPr>
          <p:cNvSpPr txBox="1"/>
          <p:nvPr/>
        </p:nvSpPr>
        <p:spPr>
          <a:xfrm>
            <a:off x="463335" y="1438408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="" xmlns:a16="http://schemas.microsoft.com/office/drawing/2014/main" id="{51F2C97F-A165-5244-8373-37C7A6A7E526}"/>
              </a:ext>
            </a:extLst>
          </p:cNvPr>
          <p:cNvSpPr txBox="1"/>
          <p:nvPr/>
        </p:nvSpPr>
        <p:spPr>
          <a:xfrm>
            <a:off x="463335" y="1097047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5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03" name="二等辺三角形 102"/>
          <p:cNvSpPr/>
          <p:nvPr/>
        </p:nvSpPr>
        <p:spPr>
          <a:xfrm>
            <a:off x="901548" y="2084331"/>
            <a:ext cx="60558" cy="45719"/>
          </a:xfrm>
          <a:prstGeom prst="triangle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b="1">
              <a:latin typeface="Helvetica"/>
              <a:cs typeface="Helvetica"/>
            </a:endParaRPr>
          </a:p>
        </p:txBody>
      </p:sp>
      <p:sp>
        <p:nvSpPr>
          <p:cNvPr id="104" name="円/楕円 103"/>
          <p:cNvSpPr/>
          <p:nvPr/>
        </p:nvSpPr>
        <p:spPr>
          <a:xfrm>
            <a:off x="894109" y="1785005"/>
            <a:ext cx="64355" cy="64349"/>
          </a:xfrm>
          <a:prstGeom prst="ellipse">
            <a:avLst/>
          </a:prstGeom>
          <a:solidFill>
            <a:srgbClr val="FF0000"/>
          </a:solidFill>
          <a:ln w="28575"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 b="1">
              <a:latin typeface="Helvetica"/>
              <a:cs typeface="Helvetica"/>
            </a:endParaRPr>
          </a:p>
        </p:txBody>
      </p:sp>
      <p:sp>
        <p:nvSpPr>
          <p:cNvPr id="134" name="テキスト ボックス 64">
            <a:extLst>
              <a:ext uri="{FF2B5EF4-FFF2-40B4-BE49-F238E27FC236}">
                <a16:creationId xmlns="" xmlns:a16="http://schemas.microsoft.com/office/drawing/2014/main" id="{25475C08-8620-2A47-820C-6823C49591D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86452" y="615539"/>
            <a:ext cx="38985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dirty="0">
                <a:latin typeface="Helvetica" charset="0"/>
                <a:cs typeface="Helvetica" charset="0"/>
              </a:rPr>
              <a:t>B</a:t>
            </a:r>
            <a:endParaRPr lang="ja-JP" altLang="en-US" dirty="0">
              <a:latin typeface="Helvetica" charset="0"/>
              <a:cs typeface="Helvetica" charset="0"/>
            </a:endParaRPr>
          </a:p>
        </p:txBody>
      </p:sp>
      <p:sp>
        <p:nvSpPr>
          <p:cNvPr id="135" name="テキスト ボックス 64">
            <a:extLst>
              <a:ext uri="{FF2B5EF4-FFF2-40B4-BE49-F238E27FC236}">
                <a16:creationId xmlns="" xmlns:a16="http://schemas.microsoft.com/office/drawing/2014/main" id="{25475C08-8620-2A47-820C-6823C49591D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0984" y="4425108"/>
            <a:ext cx="406932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dirty="0">
                <a:latin typeface="Helvetica" charset="0"/>
                <a:cs typeface="Helvetica" charset="0"/>
              </a:rPr>
              <a:t>C</a:t>
            </a:r>
            <a:endParaRPr lang="ja-JP" altLang="en-US" dirty="0">
              <a:latin typeface="Helvetica" charset="0"/>
              <a:cs typeface="Helvetica" charset="0"/>
            </a:endParaRPr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1013946" y="4631707"/>
            <a:ext cx="9798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α</a:t>
            </a:r>
            <a:r>
              <a:rPr kumimoji="1" lang="en-US" altLang="ja-JP" sz="1200" b="1" dirty="0">
                <a:latin typeface="Helvetica"/>
                <a:cs typeface="Helvetica"/>
              </a:rPr>
              <a:t>-ZIKV IgG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 rotWithShape="1">
          <a:blip r:embed="rId5"/>
          <a:srcRect l="7766" b="6904"/>
          <a:stretch/>
        </p:blipFill>
        <p:spPr>
          <a:xfrm>
            <a:off x="680223" y="5256328"/>
            <a:ext cx="1869527" cy="1236808"/>
          </a:xfrm>
          <a:prstGeom prst="rect">
            <a:avLst/>
          </a:prstGeom>
        </p:spPr>
      </p:pic>
      <p:sp>
        <p:nvSpPr>
          <p:cNvPr id="86" name="テキスト ボックス 85">
            <a:extLst>
              <a:ext uri="{FF2B5EF4-FFF2-40B4-BE49-F238E27FC236}">
                <a16:creationId xmlns="" xmlns:a16="http://schemas.microsoft.com/office/drawing/2014/main" id="{F07E629E-B719-D946-9289-C4F6303E9A11}"/>
              </a:ext>
            </a:extLst>
          </p:cNvPr>
          <p:cNvSpPr txBox="1"/>
          <p:nvPr/>
        </p:nvSpPr>
        <p:spPr>
          <a:xfrm>
            <a:off x="450244" y="6290576"/>
            <a:ext cx="262627" cy="2417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="" xmlns:a16="http://schemas.microsoft.com/office/drawing/2014/main" id="{F07E629E-B719-D946-9289-C4F6303E9A11}"/>
              </a:ext>
            </a:extLst>
          </p:cNvPr>
          <p:cNvSpPr txBox="1"/>
          <p:nvPr/>
        </p:nvSpPr>
        <p:spPr>
          <a:xfrm>
            <a:off x="449754" y="6013577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="" xmlns:a16="http://schemas.microsoft.com/office/drawing/2014/main" id="{F07E629E-B719-D946-9289-C4F6303E9A11}"/>
              </a:ext>
            </a:extLst>
          </p:cNvPr>
          <p:cNvSpPr txBox="1"/>
          <p:nvPr/>
        </p:nvSpPr>
        <p:spPr>
          <a:xfrm>
            <a:off x="449754" y="5729443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="" xmlns:a16="http://schemas.microsoft.com/office/drawing/2014/main" id="{F07E629E-B719-D946-9289-C4F6303E9A11}"/>
              </a:ext>
            </a:extLst>
          </p:cNvPr>
          <p:cNvSpPr txBox="1"/>
          <p:nvPr/>
        </p:nvSpPr>
        <p:spPr>
          <a:xfrm>
            <a:off x="450244" y="5452444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3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="" xmlns:a16="http://schemas.microsoft.com/office/drawing/2014/main" id="{F07E629E-B719-D946-9289-C4F6303E9A11}"/>
              </a:ext>
            </a:extLst>
          </p:cNvPr>
          <p:cNvSpPr txBox="1"/>
          <p:nvPr/>
        </p:nvSpPr>
        <p:spPr>
          <a:xfrm>
            <a:off x="449754" y="5183311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92" name="テキスト ボックス 91"/>
          <p:cNvSpPr txBox="1"/>
          <p:nvPr/>
        </p:nvSpPr>
        <p:spPr>
          <a:xfrm rot="16200000">
            <a:off x="-196458" y="5757290"/>
            <a:ext cx="107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/>
                <a:cs typeface="Helvetica"/>
              </a:rPr>
              <a:t>O.D. 450 nm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="" xmlns:a16="http://schemas.microsoft.com/office/drawing/2014/main" id="{881C648C-4D20-384D-AC37-A3723D2ABD15}"/>
              </a:ext>
            </a:extLst>
          </p:cNvPr>
          <p:cNvSpPr txBox="1"/>
          <p:nvPr/>
        </p:nvSpPr>
        <p:spPr>
          <a:xfrm>
            <a:off x="901252" y="6502439"/>
            <a:ext cx="13322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Helvetica"/>
                <a:cs typeface="Helvetica"/>
              </a:rPr>
              <a:t>ZIKV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32" name="テキスト ボックス 131">
            <a:extLst>
              <a:ext uri="{FF2B5EF4-FFF2-40B4-BE49-F238E27FC236}">
                <a16:creationId xmlns="" xmlns:a16="http://schemas.microsoft.com/office/drawing/2014/main" id="{881C648C-4D20-384D-AC37-A3723D2ABD15}"/>
              </a:ext>
            </a:extLst>
          </p:cNvPr>
          <p:cNvSpPr txBox="1"/>
          <p:nvPr/>
        </p:nvSpPr>
        <p:spPr>
          <a:xfrm>
            <a:off x="1667901" y="6497061"/>
            <a:ext cx="8149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Helvetica"/>
                <a:cs typeface="Helvetica"/>
              </a:rPr>
              <a:t>MOG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="" xmlns:a16="http://schemas.microsoft.com/office/drawing/2014/main" id="{DE107980-2943-BD4E-936A-8EB9F837DD56}"/>
              </a:ext>
            </a:extLst>
          </p:cNvPr>
          <p:cNvSpPr txBox="1"/>
          <p:nvPr/>
        </p:nvSpPr>
        <p:spPr>
          <a:xfrm>
            <a:off x="781291" y="6501197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TRL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37" name="テキスト ボックス 64">
            <a:extLst>
              <a:ext uri="{FF2B5EF4-FFF2-40B4-BE49-F238E27FC236}">
                <a16:creationId xmlns="" xmlns:a16="http://schemas.microsoft.com/office/drawing/2014/main" id="{25475C08-8620-2A47-820C-6823C49591D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18706" y="4427763"/>
            <a:ext cx="406932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dirty="0">
                <a:latin typeface="Helvetica" charset="0"/>
                <a:cs typeface="Helvetica" charset="0"/>
              </a:rPr>
              <a:t>D</a:t>
            </a:r>
            <a:endParaRPr lang="ja-JP" altLang="en-US" dirty="0">
              <a:latin typeface="Helvetica" charset="0"/>
              <a:cs typeface="Helvetica" charset="0"/>
            </a:endParaRPr>
          </a:p>
        </p:txBody>
      </p:sp>
      <p:cxnSp>
        <p:nvCxnSpPr>
          <p:cNvPr id="138" name="直線コネクタ 137">
            <a:extLst>
              <a:ext uri="{FF2B5EF4-FFF2-40B4-BE49-F238E27FC236}">
                <a16:creationId xmlns="" xmlns:a16="http://schemas.microsoft.com/office/drawing/2014/main" id="{6DC12DAF-D84D-A149-BACF-21771DAE9F2A}"/>
              </a:ext>
            </a:extLst>
          </p:cNvPr>
          <p:cNvCxnSpPr>
            <a:cxnSpLocks/>
          </p:cNvCxnSpPr>
          <p:nvPr/>
        </p:nvCxnSpPr>
        <p:spPr>
          <a:xfrm>
            <a:off x="1002820" y="5219158"/>
            <a:ext cx="1004327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9" name="テキスト ボックス 138">
            <a:extLst>
              <a:ext uri="{FF2B5EF4-FFF2-40B4-BE49-F238E27FC236}">
                <a16:creationId xmlns="" xmlns:a16="http://schemas.microsoft.com/office/drawing/2014/main" id="{881C648C-4D20-384D-AC37-A3723D2ABD15}"/>
              </a:ext>
            </a:extLst>
          </p:cNvPr>
          <p:cNvSpPr txBox="1"/>
          <p:nvPr/>
        </p:nvSpPr>
        <p:spPr>
          <a:xfrm>
            <a:off x="1180108" y="4976874"/>
            <a:ext cx="6524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Helvetica"/>
                <a:cs typeface="Helvetica"/>
              </a:rPr>
              <a:t>N.S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cxnSp>
        <p:nvCxnSpPr>
          <p:cNvPr id="140" name="直線コネクタ 139">
            <a:extLst>
              <a:ext uri="{FF2B5EF4-FFF2-40B4-BE49-F238E27FC236}">
                <a16:creationId xmlns="" xmlns:a16="http://schemas.microsoft.com/office/drawing/2014/main" id="{6DC12DAF-D84D-A149-BACF-21771DAE9F2A}"/>
              </a:ext>
            </a:extLst>
          </p:cNvPr>
          <p:cNvCxnSpPr>
            <a:cxnSpLocks/>
          </p:cNvCxnSpPr>
          <p:nvPr/>
        </p:nvCxnSpPr>
        <p:spPr>
          <a:xfrm>
            <a:off x="1002820" y="5441227"/>
            <a:ext cx="537047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1" name="テキスト ボックス 140">
            <a:extLst>
              <a:ext uri="{FF2B5EF4-FFF2-40B4-BE49-F238E27FC236}">
                <a16:creationId xmlns="" xmlns:a16="http://schemas.microsoft.com/office/drawing/2014/main" id="{881C648C-4D20-384D-AC37-A3723D2ABD15}"/>
              </a:ext>
            </a:extLst>
          </p:cNvPr>
          <p:cNvSpPr txBox="1"/>
          <p:nvPr/>
        </p:nvSpPr>
        <p:spPr>
          <a:xfrm>
            <a:off x="1089007" y="5274913"/>
            <a:ext cx="4594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***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pic>
        <p:nvPicPr>
          <p:cNvPr id="142" name="図 141"/>
          <p:cNvPicPr>
            <a:picLocks noChangeAspect="1"/>
          </p:cNvPicPr>
          <p:nvPr/>
        </p:nvPicPr>
        <p:blipFill rotWithShape="1">
          <a:blip r:embed="rId6"/>
          <a:srcRect l="7120" b="5326"/>
          <a:stretch/>
        </p:blipFill>
        <p:spPr>
          <a:xfrm>
            <a:off x="5127273" y="5340579"/>
            <a:ext cx="1230349" cy="1239188"/>
          </a:xfrm>
          <a:prstGeom prst="rect">
            <a:avLst/>
          </a:prstGeom>
        </p:spPr>
      </p:pic>
      <p:pic>
        <p:nvPicPr>
          <p:cNvPr id="143" name="図 142"/>
          <p:cNvPicPr>
            <a:picLocks noChangeAspect="1"/>
          </p:cNvPicPr>
          <p:nvPr/>
        </p:nvPicPr>
        <p:blipFill rotWithShape="1">
          <a:blip r:embed="rId7"/>
          <a:srcRect l="5189" b="6163"/>
          <a:stretch/>
        </p:blipFill>
        <p:spPr>
          <a:xfrm>
            <a:off x="3886438" y="5343349"/>
            <a:ext cx="1269971" cy="1241960"/>
          </a:xfrm>
          <a:prstGeom prst="rect">
            <a:avLst/>
          </a:prstGeom>
        </p:spPr>
      </p:pic>
      <p:sp>
        <p:nvSpPr>
          <p:cNvPr id="144" name="テキスト ボックス 143"/>
          <p:cNvSpPr txBox="1"/>
          <p:nvPr/>
        </p:nvSpPr>
        <p:spPr>
          <a:xfrm rot="16200000">
            <a:off x="3640126" y="6565649"/>
            <a:ext cx="323622" cy="1661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IL-17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cxnSp>
        <p:nvCxnSpPr>
          <p:cNvPr id="145" name="直線矢印コネクタ 144"/>
          <p:cNvCxnSpPr/>
          <p:nvPr/>
        </p:nvCxnSpPr>
        <p:spPr>
          <a:xfrm>
            <a:off x="4457840" y="6678381"/>
            <a:ext cx="1896205" cy="0"/>
          </a:xfrm>
          <a:prstGeom prst="straightConnector1">
            <a:avLst/>
          </a:prstGeom>
          <a:ln w="22225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6" name="テキスト ボックス 145"/>
          <p:cNvSpPr txBox="1"/>
          <p:nvPr/>
        </p:nvSpPr>
        <p:spPr>
          <a:xfrm>
            <a:off x="3937933" y="6535878"/>
            <a:ext cx="341454" cy="1648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IFN-γ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47" name="正方形/長方形 146"/>
          <p:cNvSpPr/>
          <p:nvPr/>
        </p:nvSpPr>
        <p:spPr>
          <a:xfrm>
            <a:off x="4066838" y="5411469"/>
            <a:ext cx="1019972" cy="1028969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48" name="正方形/長方形 147"/>
          <p:cNvSpPr/>
          <p:nvPr/>
        </p:nvSpPr>
        <p:spPr>
          <a:xfrm>
            <a:off x="5279482" y="5411541"/>
            <a:ext cx="1019972" cy="1028969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49" name="テキスト ボックス 148"/>
          <p:cNvSpPr txBox="1"/>
          <p:nvPr/>
        </p:nvSpPr>
        <p:spPr>
          <a:xfrm>
            <a:off x="3997626" y="5344735"/>
            <a:ext cx="4841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.6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50" name="テキスト ボックス 149"/>
          <p:cNvSpPr txBox="1"/>
          <p:nvPr/>
        </p:nvSpPr>
        <p:spPr>
          <a:xfrm>
            <a:off x="5205359" y="5344735"/>
            <a:ext cx="4841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.65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51" name="テキスト ボックス 150"/>
          <p:cNvSpPr txBox="1"/>
          <p:nvPr/>
        </p:nvSpPr>
        <p:spPr>
          <a:xfrm>
            <a:off x="4692636" y="6199977"/>
            <a:ext cx="4841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.55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52" name="テキスト ボックス 151"/>
          <p:cNvSpPr txBox="1"/>
          <p:nvPr/>
        </p:nvSpPr>
        <p:spPr>
          <a:xfrm>
            <a:off x="5903974" y="6199977"/>
            <a:ext cx="4841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.83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cxnSp>
        <p:nvCxnSpPr>
          <p:cNvPr id="153" name="直線矢印コネクタ 152"/>
          <p:cNvCxnSpPr/>
          <p:nvPr/>
        </p:nvCxnSpPr>
        <p:spPr>
          <a:xfrm flipV="1">
            <a:off x="3817642" y="5417118"/>
            <a:ext cx="0" cy="863452"/>
          </a:xfrm>
          <a:prstGeom prst="straightConnector1">
            <a:avLst/>
          </a:prstGeom>
          <a:ln w="22225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4" name="テキスト ボックス 153">
            <a:extLst>
              <a:ext uri="{FF2B5EF4-FFF2-40B4-BE49-F238E27FC236}">
                <a16:creationId xmlns="" xmlns:a16="http://schemas.microsoft.com/office/drawing/2014/main" id="{AD5ABEC9-29AB-684B-8E09-8440F2150934}"/>
              </a:ext>
            </a:extLst>
          </p:cNvPr>
          <p:cNvSpPr txBox="1"/>
          <p:nvPr/>
        </p:nvSpPr>
        <p:spPr>
          <a:xfrm>
            <a:off x="4102049" y="5166358"/>
            <a:ext cx="8087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     CTRL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55" name="テキスト ボックス 154">
            <a:extLst>
              <a:ext uri="{FF2B5EF4-FFF2-40B4-BE49-F238E27FC236}">
                <a16:creationId xmlns="" xmlns:a16="http://schemas.microsoft.com/office/drawing/2014/main" id="{AD5ABEC9-29AB-684B-8E09-8440F2150934}"/>
              </a:ext>
            </a:extLst>
          </p:cNvPr>
          <p:cNvSpPr txBox="1"/>
          <p:nvPr/>
        </p:nvSpPr>
        <p:spPr>
          <a:xfrm>
            <a:off x="5542792" y="5166358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ZIKV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56" name="テキスト ボックス 155"/>
          <p:cNvSpPr txBox="1"/>
          <p:nvPr/>
        </p:nvSpPr>
        <p:spPr>
          <a:xfrm rot="16200000">
            <a:off x="2506043" y="5767377"/>
            <a:ext cx="20617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Gated on CD4+ T cells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163034524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28575">
          <a:solidFill>
            <a:schemeClr val="tx1"/>
          </a:solidFill>
        </a:ln>
        <a:effectLst/>
      </a:spPr>
      <a:bodyPr rtlCol="0" anchor="ctr"/>
      <a:lstStyle>
        <a:defPPr algn="ctr">
          <a:defRPr sz="1200" b="1">
            <a:latin typeface="Helvetica"/>
            <a:cs typeface="Helvetica"/>
          </a:defRPr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81</TotalTime>
  <Words>84</Words>
  <Application>Microsoft Macintosh PowerPoint</Application>
  <PresentationFormat>画面に合わせる (4:3)</PresentationFormat>
  <Paragraphs>60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ＭＳ Ｐゴシック</vt:lpstr>
      <vt:lpstr>ホワイト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5.003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IDC</dc:creator>
  <cp:keywords/>
  <dc:description/>
  <cp:lastModifiedBy>神山長慶</cp:lastModifiedBy>
  <cp:revision>330</cp:revision>
  <cp:lastPrinted>2024-05-22T05:30:17Z</cp:lastPrinted>
  <dcterms:created xsi:type="dcterms:W3CDTF">2022-03-10T04:52:23Z</dcterms:created>
  <dcterms:modified xsi:type="dcterms:W3CDTF">2025-11-05T08:07:36Z</dcterms:modified>
  <cp:category/>
</cp:coreProperties>
</file>